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</p:sldIdLst>
  <p:sldSz cx="6858000" cy="9144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D18929-FC90-4BB2-9154-4756151A2B6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EC004C-5087-4F0B-9CCF-1CEDBE57D6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7676E2-9856-44AD-A242-A7C9E9FED3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6599C-7D1A-4FCD-BA42-4DCDC32103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F6BB3B-08F9-4276-89C3-FDE7310CD7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B9EDA1-9CEB-4288-9EF1-B195FD3889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D932BF-3E1C-41A0-AAA7-60DCA33D41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87212D-979D-4199-A73F-E4210A63032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F54477-7DC7-4F96-8ACC-3AE67208293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B610C-4C8C-41CC-A3CC-FE99A44EACB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C388A6-7FCB-478B-93D8-9EBA47D1CF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5E239-1B89-4B0F-ADD9-3EF6672DFD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7000"/>
          </a:bodyPr>
          <a:p>
            <a:pPr marL="298440" indent="-29844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646200" indent="-2484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994320" indent="-19872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392120" indent="-19872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1789920" indent="-19872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AFC721-C427-4393-B4FE-E4E28992A539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555480" y="3855960"/>
            <a:ext cx="5745240" cy="1747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Additional file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7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Hybridization intensity maps for genes identified in Figure 2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3" name=""/>
          <p:cNvGrpSpPr/>
          <p:nvPr/>
        </p:nvGrpSpPr>
        <p:grpSpPr>
          <a:xfrm>
            <a:off x="417600" y="1828800"/>
            <a:ext cx="6097680" cy="4572000"/>
            <a:chOff x="417600" y="1828800"/>
            <a:chExt cx="6097680" cy="4572000"/>
          </a:xfrm>
        </p:grpSpPr>
        <p:pic>
          <p:nvPicPr>
            <p:cNvPr id="84" name="" descr=""/>
            <p:cNvPicPr/>
            <p:nvPr/>
          </p:nvPicPr>
          <p:blipFill>
            <a:blip r:embed="rId1"/>
            <a:stretch/>
          </p:blipFill>
          <p:spPr>
            <a:xfrm>
              <a:off x="41760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5" name=""/>
            <p:cNvSpPr/>
            <p:nvPr/>
          </p:nvSpPr>
          <p:spPr>
            <a:xfrm flipH="1">
              <a:off x="3464640" y="5029200"/>
              <a:ext cx="31140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 flipH="1">
              <a:off x="3793680" y="222408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976480" y="222408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" descr=""/>
          <p:cNvPicPr/>
          <p:nvPr/>
        </p:nvPicPr>
        <p:blipFill>
          <a:blip r:embed="rId1"/>
          <a:stretch/>
        </p:blipFill>
        <p:spPr>
          <a:xfrm>
            <a:off x="593640" y="1754280"/>
            <a:ext cx="6234120" cy="4674960"/>
          </a:xfrm>
          <a:prstGeom prst="rect">
            <a:avLst/>
          </a:prstGeom>
          <a:ln w="0">
            <a:noFill/>
          </a:ln>
        </p:spPr>
      </p:pic>
      <p:sp>
        <p:nvSpPr>
          <p:cNvPr id="89" name=""/>
          <p:cNvSpPr/>
          <p:nvPr/>
        </p:nvSpPr>
        <p:spPr>
          <a:xfrm flipH="1">
            <a:off x="2481120" y="5038560"/>
            <a:ext cx="1581120" cy="91620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 flipH="1">
            <a:off x="427320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229716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" name="" descr=""/>
          <p:cNvPicPr/>
          <p:nvPr/>
        </p:nvPicPr>
        <p:blipFill>
          <a:blip r:embed="rId1"/>
          <a:stretch/>
        </p:blipFill>
        <p:spPr>
          <a:xfrm>
            <a:off x="598320" y="1754280"/>
            <a:ext cx="6235920" cy="4674960"/>
          </a:xfrm>
          <a:prstGeom prst="rect">
            <a:avLst/>
          </a:prstGeom>
          <a:ln w="0">
            <a:noFill/>
          </a:ln>
        </p:spPr>
      </p:pic>
      <p:sp>
        <p:nvSpPr>
          <p:cNvPr id="93" name=""/>
          <p:cNvSpPr/>
          <p:nvPr/>
        </p:nvSpPr>
        <p:spPr>
          <a:xfrm flipH="1">
            <a:off x="2474280" y="5038560"/>
            <a:ext cx="1587240" cy="91620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 flipH="1">
            <a:off x="427320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2297160" y="216216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"/>
          <p:cNvGrpSpPr/>
          <p:nvPr/>
        </p:nvGrpSpPr>
        <p:grpSpPr>
          <a:xfrm>
            <a:off x="368280" y="2095560"/>
            <a:ext cx="6097680" cy="4572000"/>
            <a:chOff x="368280" y="2095560"/>
            <a:chExt cx="6097680" cy="4572000"/>
          </a:xfrm>
        </p:grpSpPr>
        <p:pic>
          <p:nvPicPr>
            <p:cNvPr id="43" name="" descr=""/>
            <p:cNvPicPr/>
            <p:nvPr/>
          </p:nvPicPr>
          <p:blipFill>
            <a:blip r:embed="rId1"/>
            <a:stretch/>
          </p:blipFill>
          <p:spPr>
            <a:xfrm>
              <a:off x="368280" y="209556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"/>
            <p:cNvSpPr/>
            <p:nvPr/>
          </p:nvSpPr>
          <p:spPr>
            <a:xfrm flipH="1">
              <a:off x="4161600" y="5300640"/>
              <a:ext cx="23652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 flipH="1">
              <a:off x="4409640" y="24908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83040" y="248292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7" name="" descr=""/>
          <p:cNvPicPr/>
          <p:nvPr/>
        </p:nvPicPr>
        <p:blipFill>
          <a:blip r:embed="rId1"/>
          <a:stretch/>
        </p:blipFill>
        <p:spPr>
          <a:xfrm>
            <a:off x="399960" y="1828800"/>
            <a:ext cx="6097680" cy="4572000"/>
          </a:xfrm>
          <a:prstGeom prst="rect">
            <a:avLst/>
          </a:prstGeom>
          <a:ln w="0">
            <a:noFill/>
          </a:ln>
        </p:spPr>
      </p:pic>
      <p:sp>
        <p:nvSpPr>
          <p:cNvPr id="48" name=""/>
          <p:cNvSpPr/>
          <p:nvPr/>
        </p:nvSpPr>
        <p:spPr>
          <a:xfrm flipH="1">
            <a:off x="2320200" y="5037120"/>
            <a:ext cx="1128600" cy="90648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3553920" y="222084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2168640" y="2228760"/>
            <a:ext cx="126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1" name=""/>
          <p:cNvGrpSpPr/>
          <p:nvPr/>
        </p:nvGrpSpPr>
        <p:grpSpPr>
          <a:xfrm>
            <a:off x="330120" y="1828800"/>
            <a:ext cx="6097680" cy="4572000"/>
            <a:chOff x="330120" y="1828800"/>
            <a:chExt cx="6097680" cy="4572000"/>
          </a:xfrm>
        </p:grpSpPr>
        <p:pic>
          <p:nvPicPr>
            <p:cNvPr id="52" name="" descr=""/>
            <p:cNvPicPr/>
            <p:nvPr/>
          </p:nvPicPr>
          <p:blipFill>
            <a:blip r:embed="rId1"/>
            <a:stretch/>
          </p:blipFill>
          <p:spPr>
            <a:xfrm>
              <a:off x="330120" y="182880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" name=""/>
            <p:cNvSpPr/>
            <p:nvPr/>
          </p:nvSpPr>
          <p:spPr>
            <a:xfrm>
              <a:off x="2913120" y="5027760"/>
              <a:ext cx="1193760" cy="91440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 flipH="1">
              <a:off x="4266720" y="22208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587680" y="22208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347760" y="1828800"/>
            <a:ext cx="6097320" cy="4572000"/>
            <a:chOff x="347760" y="1828800"/>
            <a:chExt cx="6097320" cy="4572000"/>
          </a:xfrm>
        </p:grpSpPr>
        <p:pic>
          <p:nvPicPr>
            <p:cNvPr id="57" name="" descr=""/>
            <p:cNvPicPr/>
            <p:nvPr/>
          </p:nvPicPr>
          <p:blipFill>
            <a:blip r:embed="rId1"/>
            <a:stretch/>
          </p:blipFill>
          <p:spPr>
            <a:xfrm>
              <a:off x="347760" y="1828800"/>
              <a:ext cx="609732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1981080" y="5037120"/>
              <a:ext cx="424080" cy="91440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 flipH="1">
              <a:off x="2534760" y="223200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1193760" y="223200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393840" y="1828800"/>
            <a:ext cx="6097320" cy="4572000"/>
          </a:xfrm>
          <a:prstGeom prst="rect">
            <a:avLst/>
          </a:prstGeom>
          <a:ln w="0">
            <a:noFill/>
          </a:ln>
        </p:spPr>
      </p:pic>
      <p:sp>
        <p:nvSpPr>
          <p:cNvPr id="62" name=""/>
          <p:cNvSpPr/>
          <p:nvPr/>
        </p:nvSpPr>
        <p:spPr>
          <a:xfrm flipH="1">
            <a:off x="1922400" y="5033880"/>
            <a:ext cx="223920" cy="906480"/>
          </a:xfrm>
          <a:prstGeom prst="rect">
            <a:avLst/>
          </a:prstGeom>
          <a:noFill/>
          <a:ln w="2844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 flipH="1">
            <a:off x="2188800" y="2236680"/>
            <a:ext cx="127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714680" y="2236680"/>
            <a:ext cx="1267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"/>
          <p:cNvGrpSpPr/>
          <p:nvPr/>
        </p:nvGrpSpPr>
        <p:grpSpPr>
          <a:xfrm>
            <a:off x="382680" y="1828800"/>
            <a:ext cx="6097320" cy="4572000"/>
            <a:chOff x="382680" y="1828800"/>
            <a:chExt cx="6097320" cy="4572000"/>
          </a:xfrm>
        </p:grpSpPr>
        <p:pic>
          <p:nvPicPr>
            <p:cNvPr id="66" name="" descr=""/>
            <p:cNvPicPr/>
            <p:nvPr/>
          </p:nvPicPr>
          <p:blipFill>
            <a:blip r:embed="rId1"/>
            <a:stretch/>
          </p:blipFill>
          <p:spPr>
            <a:xfrm>
              <a:off x="382680" y="1828800"/>
              <a:ext cx="609732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"/>
            <p:cNvSpPr/>
            <p:nvPr/>
          </p:nvSpPr>
          <p:spPr>
            <a:xfrm flipH="1">
              <a:off x="5003280" y="221616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813120" y="221472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 flipH="1">
              <a:off x="4158360" y="5029200"/>
              <a:ext cx="590760" cy="91584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0" name=""/>
          <p:cNvGrpSpPr/>
          <p:nvPr/>
        </p:nvGrpSpPr>
        <p:grpSpPr>
          <a:xfrm>
            <a:off x="295200" y="1846440"/>
            <a:ext cx="6097680" cy="4572000"/>
            <a:chOff x="295200" y="1846440"/>
            <a:chExt cx="6097680" cy="4572000"/>
          </a:xfrm>
        </p:grpSpPr>
        <p:pic>
          <p:nvPicPr>
            <p:cNvPr id="71" name="" descr=""/>
            <p:cNvPicPr/>
            <p:nvPr/>
          </p:nvPicPr>
          <p:blipFill>
            <a:blip r:embed="rId1"/>
            <a:stretch/>
          </p:blipFill>
          <p:spPr>
            <a:xfrm>
              <a:off x="295200" y="1846440"/>
              <a:ext cx="6097680" cy="4572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 flipH="1">
              <a:off x="2490840" y="5046840"/>
              <a:ext cx="1379520" cy="90612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 flipH="1">
              <a:off x="448596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941480" y="223524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"/>
          <p:cNvSpPr/>
          <p:nvPr/>
        </p:nvSpPr>
        <p:spPr>
          <a:xfrm>
            <a:off x="2549520" y="2014560"/>
            <a:ext cx="6746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TNC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6" name=""/>
          <p:cNvGrpSpPr/>
          <p:nvPr/>
        </p:nvGrpSpPr>
        <p:grpSpPr>
          <a:xfrm>
            <a:off x="495360" y="1828800"/>
            <a:ext cx="6094440" cy="4570560"/>
            <a:chOff x="495360" y="1828800"/>
            <a:chExt cx="6094440" cy="4570560"/>
          </a:xfrm>
        </p:grpSpPr>
        <p:pic>
          <p:nvPicPr>
            <p:cNvPr id="77" name="" descr=""/>
            <p:cNvPicPr/>
            <p:nvPr/>
          </p:nvPicPr>
          <p:blipFill>
            <a:blip r:embed="rId1"/>
            <a:stretch/>
          </p:blipFill>
          <p:spPr>
            <a:xfrm>
              <a:off x="495360" y="1828800"/>
              <a:ext cx="6094440" cy="457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"/>
            <p:cNvSpPr/>
            <p:nvPr/>
          </p:nvSpPr>
          <p:spPr>
            <a:xfrm flipH="1">
              <a:off x="2830680" y="5038560"/>
              <a:ext cx="109440" cy="906480"/>
            </a:xfrm>
            <a:prstGeom prst="rect">
              <a:avLst/>
            </a:prstGeom>
            <a:noFill/>
            <a:ln w="28440">
              <a:solidFill>
                <a:srgbClr val="008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706840" y="2225520"/>
              <a:ext cx="126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2928600" y="2227320"/>
              <a:ext cx="1270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1" name=""/>
          <p:cNvSpPr/>
          <p:nvPr/>
        </p:nvSpPr>
        <p:spPr>
          <a:xfrm>
            <a:off x="2548080" y="2082960"/>
            <a:ext cx="736560" cy="91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662200" y="2009880"/>
            <a:ext cx="4474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TNC,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2-16T17:22:47Z</dcterms:created>
  <dc:creator>UT M.D. Anderson</dc:creator>
  <dc:description/>
  <dc:language>en-US</dc:language>
  <cp:lastModifiedBy>Ralf Krahe, Ph.D.</cp:lastModifiedBy>
  <cp:lastPrinted>2007-01-31T17:26:47Z</cp:lastPrinted>
  <dcterms:modified xsi:type="dcterms:W3CDTF">2008-03-05T01:00:10Z</dcterms:modified>
  <cp:revision>85</cp:revision>
  <dc:subject/>
  <dc:title>PowerPoint Presentation</dc:title>
</cp:coreProperties>
</file>